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92D1F2-6826-418C-B7DB-E0AEAB82480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DD0023-566E-4C04-A8FA-41D417E9EF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A0C77F-600A-444F-9318-F16C2936FFC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099383-6642-4E5D-8659-E9CE354D5B9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1DF241-0B7F-4D2E-8452-280D2E1671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810C5B-9AA9-4670-AFA4-B17DCF41AC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F11DCE-88E0-4FAB-A80D-7AB613BCE7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AC47CF-47F1-4D70-A131-0D31DDAA76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F3A9B8-4574-454D-8E0E-37029D7DBA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ADA536-A8D8-48FD-A548-08CC37CDD3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72527E-4917-489D-BF56-73F60136BE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116ACF-6699-4F88-92B9-158684983B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2A9F43-70A4-4CB3-8D19-5FD516C7F131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o 1"/>
          <p:cNvGrpSpPr/>
          <p:nvPr/>
        </p:nvGrpSpPr>
        <p:grpSpPr>
          <a:xfrm>
            <a:off x="2124000" y="2460600"/>
            <a:ext cx="4802760" cy="1893240"/>
            <a:chOff x="2124000" y="2460600"/>
            <a:chExt cx="4802760" cy="1893240"/>
          </a:xfrm>
        </p:grpSpPr>
        <p:sp>
          <p:nvSpPr>
            <p:cNvPr id="42" name="CasellaDiTesto 9"/>
            <p:cNvSpPr/>
            <p:nvPr/>
          </p:nvSpPr>
          <p:spPr>
            <a:xfrm>
              <a:off x="3189240" y="4077360"/>
              <a:ext cx="950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CasellaDiTesto 10"/>
            <p:cNvSpPr/>
            <p:nvPr/>
          </p:nvSpPr>
          <p:spPr>
            <a:xfrm>
              <a:off x="4950000" y="4077360"/>
              <a:ext cx="1206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S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4" name="Grafico 5" descr=""/>
            <p:cNvPicPr/>
            <p:nvPr/>
          </p:nvPicPr>
          <p:blipFill>
            <a:blip r:embed="rId1"/>
            <a:stretch/>
          </p:blipFill>
          <p:spPr>
            <a:xfrm>
              <a:off x="2578320" y="2460600"/>
              <a:ext cx="3499200" cy="1782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CasellaDiTesto 33"/>
            <p:cNvSpPr/>
            <p:nvPr/>
          </p:nvSpPr>
          <p:spPr>
            <a:xfrm>
              <a:off x="2447640" y="3976200"/>
              <a:ext cx="277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CasellaDiTesto 34"/>
            <p:cNvSpPr/>
            <p:nvPr/>
          </p:nvSpPr>
          <p:spPr>
            <a:xfrm>
              <a:off x="2382480" y="3760560"/>
              <a:ext cx="372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CasellaDiTesto 35"/>
            <p:cNvSpPr/>
            <p:nvPr/>
          </p:nvSpPr>
          <p:spPr>
            <a:xfrm>
              <a:off x="2325600" y="354492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CasellaDiTesto 36"/>
            <p:cNvSpPr/>
            <p:nvPr/>
          </p:nvSpPr>
          <p:spPr>
            <a:xfrm>
              <a:off x="2325600" y="332964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CasellaDiTesto 37"/>
            <p:cNvSpPr/>
            <p:nvPr/>
          </p:nvSpPr>
          <p:spPr>
            <a:xfrm>
              <a:off x="2325600" y="311400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CasellaDiTesto 38"/>
            <p:cNvSpPr/>
            <p:nvPr/>
          </p:nvSpPr>
          <p:spPr>
            <a:xfrm>
              <a:off x="2325600" y="289836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CasellaDiTesto 39"/>
            <p:cNvSpPr/>
            <p:nvPr/>
          </p:nvSpPr>
          <p:spPr>
            <a:xfrm>
              <a:off x="2325600" y="268128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CasellaDiTesto 40"/>
            <p:cNvSpPr/>
            <p:nvPr/>
          </p:nvSpPr>
          <p:spPr>
            <a:xfrm>
              <a:off x="2325600" y="246600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CasellaDiTesto 41"/>
            <p:cNvSpPr/>
            <p:nvPr/>
          </p:nvSpPr>
          <p:spPr>
            <a:xfrm rot="16200000">
              <a:off x="1812240" y="3142080"/>
              <a:ext cx="900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ime in (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ttangolo 16"/>
            <p:cNvSpPr/>
            <p:nvPr/>
          </p:nvSpPr>
          <p:spPr>
            <a:xfrm>
              <a:off x="5816880" y="3489480"/>
              <a:ext cx="142560" cy="1425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ttangolo 17"/>
            <p:cNvSpPr/>
            <p:nvPr/>
          </p:nvSpPr>
          <p:spPr>
            <a:xfrm>
              <a:off x="5816880" y="3678120"/>
              <a:ext cx="142560" cy="142560"/>
            </a:xfrm>
            <a:prstGeom prst="rect">
              <a:avLst/>
            </a:prstGeom>
            <a:solidFill>
              <a:srgbClr val="a6a6a6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ttangolo 18"/>
            <p:cNvSpPr/>
            <p:nvPr/>
          </p:nvSpPr>
          <p:spPr>
            <a:xfrm>
              <a:off x="5816880" y="3866760"/>
              <a:ext cx="142560" cy="14256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CasellaDiTesto 46"/>
            <p:cNvSpPr/>
            <p:nvPr/>
          </p:nvSpPr>
          <p:spPr>
            <a:xfrm>
              <a:off x="5930640" y="3430800"/>
              <a:ext cx="790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ocial sid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CasellaDiTesto 47"/>
            <p:cNvSpPr/>
            <p:nvPr/>
          </p:nvSpPr>
          <p:spPr>
            <a:xfrm>
              <a:off x="5928840" y="3622680"/>
              <a:ext cx="560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ent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CasellaDiTesto 48"/>
            <p:cNvSpPr/>
            <p:nvPr/>
          </p:nvSpPr>
          <p:spPr>
            <a:xfrm>
              <a:off x="5932080" y="3816000"/>
              <a:ext cx="994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-Social sid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0" name="CasellaDiTesto 3"/>
          <p:cNvSpPr/>
          <p:nvPr/>
        </p:nvSpPr>
        <p:spPr>
          <a:xfrm>
            <a:off x="1692360" y="5445000"/>
            <a:ext cx="706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 Iacono et al., Fig. S1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CasellaDiTesto 1"/>
          <p:cNvSpPr/>
          <p:nvPr/>
        </p:nvSpPr>
        <p:spPr>
          <a:xfrm>
            <a:off x="3646080" y="2205000"/>
            <a:ext cx="218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600" spc="-1" strike="noStrike">
                <a:solidFill>
                  <a:srgbClr val="000000"/>
                </a:solidFill>
                <a:latin typeface="Arial"/>
              </a:rPr>
              <a:t>SIT Habituation phas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3-05T14:15:00Z</dcterms:created>
  <dc:creator>VALERIA</dc:creator>
  <dc:description/>
  <dc:language>en-US</dc:language>
  <cp:lastModifiedBy>Claudio Savarese</cp:lastModifiedBy>
  <cp:lastPrinted>2014-12-04T14:49:48Z</cp:lastPrinted>
  <dcterms:modified xsi:type="dcterms:W3CDTF">2015-03-13T11:46:16Z</dcterms:modified>
  <cp:revision>180</cp:revision>
  <dc:subject/>
  <dc:title>Diapositiva 1</dc:title>
</cp:coreProperties>
</file>